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4" r:id="rId2"/>
    <p:sldId id="261" r:id="rId3"/>
    <p:sldId id="262" r:id="rId4"/>
    <p:sldId id="263" r:id="rId5"/>
    <p:sldId id="268" r:id="rId6"/>
    <p:sldId id="269" r:id="rId7"/>
  </p:sldIdLst>
  <p:sldSz cx="7772400" cy="100584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1AE73"/>
    <a:srgbClr val="C9D64E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6110" autoAdjust="0"/>
  </p:normalViewPr>
  <p:slideViewPr>
    <p:cSldViewPr snapToGrid="0">
      <p:cViewPr>
        <p:scale>
          <a:sx n="200" d="100"/>
          <a:sy n="200" d="100"/>
        </p:scale>
        <p:origin x="-696" y="-381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7531" y="0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r">
              <a:defRPr sz="1200"/>
            </a:lvl1pPr>
          </a:lstStyle>
          <a:p>
            <a:fld id="{F94CD09D-43C9-4013-8FEE-7DFF77CF72E6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1163638"/>
            <a:ext cx="2425700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77" tIns="45789" rIns="91577" bIns="457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946" y="4479687"/>
            <a:ext cx="5617208" cy="3665776"/>
          </a:xfrm>
          <a:prstGeom prst="rect">
            <a:avLst/>
          </a:prstGeom>
        </p:spPr>
        <p:txBody>
          <a:bodyPr vert="horz" lIns="91577" tIns="45789" rIns="91577" bIns="45789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41738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7531" y="8841738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r">
              <a:defRPr sz="1200"/>
            </a:lvl1pPr>
          </a:lstStyle>
          <a:p>
            <a:fld id="{A82BDD83-E605-4106-996D-26D57C505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049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1200" dirty="0" smtClean="0"/>
              <a:t>BCK4 tumors in </a:t>
            </a:r>
            <a:r>
              <a:rPr lang="en-US" altLang="en-US" sz="1200" i="1" dirty="0" smtClean="0"/>
              <a:t>cellulose</a:t>
            </a:r>
            <a:r>
              <a:rPr lang="en-US" altLang="en-US" sz="1200" dirty="0" smtClean="0">
                <a:solidFill>
                  <a:srgbClr val="CC0000"/>
                </a:solidFill>
              </a:rPr>
              <a:t> </a:t>
            </a:r>
            <a:r>
              <a:rPr lang="en-US" altLang="en-US" sz="1200" dirty="0" smtClean="0"/>
              <a:t>supplemented mice are pure mucinous; </a:t>
            </a:r>
            <a:r>
              <a:rPr lang="en-US" altLang="en-US" sz="1200" i="1" dirty="0" smtClean="0"/>
              <a:t>E2</a:t>
            </a:r>
            <a:r>
              <a:rPr lang="en-US" altLang="en-US" sz="1200" dirty="0" smtClean="0"/>
              <a:t> supplemented mice are mixed mucinou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2BDD83-E605-4106-996D-26D57C505F1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3185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796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940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59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517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197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733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120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42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67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062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074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90992-2E7C-4490-920B-19C921666F5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8FA70-580A-4FF5-9C6C-CC373CAC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529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8.tiff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3.tiff"/><Relationship Id="rId7" Type="http://schemas.openxmlformats.org/officeDocument/2006/relationships/image" Target="../media/image17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10" Type="http://schemas.openxmlformats.org/officeDocument/2006/relationships/image" Target="../media/image20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 descr="SK3 01 20x Muc 1 30ms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033" y="3627737"/>
            <a:ext cx="3073281" cy="23106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6" descr="SK3 01 20x H&amp;E 1 20ms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5292" y="3627737"/>
            <a:ext cx="3059643" cy="23013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 Box 7"/>
          <p:cNvSpPr txBox="1">
            <a:spLocks noChangeArrowheads="1"/>
          </p:cNvSpPr>
          <p:nvPr/>
        </p:nvSpPr>
        <p:spPr bwMode="auto">
          <a:xfrm>
            <a:off x="2509127" y="603250"/>
            <a:ext cx="6667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800" b="1" dirty="0"/>
              <a:t>H&amp;E</a:t>
            </a:r>
          </a:p>
        </p:txBody>
      </p:sp>
      <p:sp>
        <p:nvSpPr>
          <p:cNvPr id="5" name="Text Box 9"/>
          <p:cNvSpPr txBox="1">
            <a:spLocks noChangeArrowheads="1"/>
          </p:cNvSpPr>
          <p:nvPr/>
        </p:nvSpPr>
        <p:spPr bwMode="auto">
          <a:xfrm>
            <a:off x="700630" y="4277597"/>
            <a:ext cx="4635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800" dirty="0"/>
              <a:t>E2</a:t>
            </a:r>
          </a:p>
        </p:txBody>
      </p:sp>
      <p:sp>
        <p:nvSpPr>
          <p:cNvPr id="6" name="Text Box 10"/>
          <p:cNvSpPr txBox="1">
            <a:spLocks noChangeArrowheads="1"/>
          </p:cNvSpPr>
          <p:nvPr/>
        </p:nvSpPr>
        <p:spPr bwMode="auto">
          <a:xfrm>
            <a:off x="5334038" y="587375"/>
            <a:ext cx="17208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800" b="1">
                <a:solidFill>
                  <a:srgbClr val="FF33CC"/>
                </a:solidFill>
              </a:rPr>
              <a:t>Mucin</a:t>
            </a:r>
            <a:r>
              <a:rPr lang="en-US" altLang="en-US" sz="1800" b="1">
                <a:solidFill>
                  <a:srgbClr val="FF6699"/>
                </a:solidFill>
              </a:rPr>
              <a:t> </a:t>
            </a:r>
            <a:r>
              <a:rPr lang="en-US" altLang="en-US" sz="1800" b="1"/>
              <a:t>/ </a:t>
            </a:r>
            <a:r>
              <a:rPr lang="en-US" altLang="en-US" sz="1800" b="1">
                <a:solidFill>
                  <a:srgbClr val="00CC00"/>
                </a:solidFill>
              </a:rPr>
              <a:t>Nuclei</a:t>
            </a:r>
          </a:p>
        </p:txBody>
      </p:sp>
      <p:sp>
        <p:nvSpPr>
          <p:cNvPr id="7" name="Text Box 11"/>
          <p:cNvSpPr txBox="1">
            <a:spLocks noChangeArrowheads="1"/>
          </p:cNvSpPr>
          <p:nvPr/>
        </p:nvSpPr>
        <p:spPr bwMode="auto">
          <a:xfrm>
            <a:off x="361243" y="1620357"/>
            <a:ext cx="112395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800" dirty="0"/>
              <a:t>Cellulose</a:t>
            </a:r>
          </a:p>
        </p:txBody>
      </p:sp>
      <p:pic>
        <p:nvPicPr>
          <p:cNvPr id="8" name="Picture 12" descr="SK1 02R 20x H&amp;E 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5293" y="1146823"/>
            <a:ext cx="3059642" cy="2438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3" descr="SK1 02R 20x Muc 1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7323" y="1146823"/>
            <a:ext cx="3056991" cy="24359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"/>
          <p:cNvSpPr txBox="1">
            <a:spLocks noChangeArrowheads="1"/>
          </p:cNvSpPr>
          <p:nvPr/>
        </p:nvSpPr>
        <p:spPr bwMode="auto">
          <a:xfrm>
            <a:off x="297237" y="2028418"/>
            <a:ext cx="1261884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800" b="1" dirty="0" smtClean="0"/>
              <a:t>Pure</a:t>
            </a:r>
          </a:p>
          <a:p>
            <a:pPr algn="ctr" eaLnBrk="1" hangingPunct="1"/>
            <a:r>
              <a:rPr lang="en-US" altLang="en-US" sz="1800" b="1" dirty="0" smtClean="0"/>
              <a:t>Mucinous</a:t>
            </a:r>
            <a:endParaRPr lang="en-US" altLang="en-US" sz="1800" b="1" dirty="0"/>
          </a:p>
        </p:txBody>
      </p:sp>
      <p:sp>
        <p:nvSpPr>
          <p:cNvPr id="13" name="TextBox 12"/>
          <p:cNvSpPr txBox="1">
            <a:spLocks noChangeArrowheads="1"/>
          </p:cNvSpPr>
          <p:nvPr/>
        </p:nvSpPr>
        <p:spPr bwMode="auto">
          <a:xfrm>
            <a:off x="269882" y="4704431"/>
            <a:ext cx="1261884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800" b="1" dirty="0" smtClean="0"/>
              <a:t>Mixed</a:t>
            </a:r>
          </a:p>
          <a:p>
            <a:pPr algn="ctr" eaLnBrk="1" hangingPunct="1"/>
            <a:r>
              <a:rPr lang="en-US" altLang="en-US" sz="1800" b="1" dirty="0" smtClean="0"/>
              <a:t>Mucinous</a:t>
            </a:r>
            <a:endParaRPr lang="en-US" altLang="en-US" sz="18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62366" y="150090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9692877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41484" y="307301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46046" y="1212771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Cm</a:t>
            </a:r>
            <a:r>
              <a:rPr lang="en-US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s </a:t>
            </a:r>
            <a:r>
              <a:rPr lang="en-US" b="1" dirty="0" err="1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Cp</a:t>
            </a:r>
            <a:endParaRPr lang="en-US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752975" y="1212771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C vs </a:t>
            </a:r>
            <a:r>
              <a:rPr lang="en-US" b="1" dirty="0" err="1" smtClean="0">
                <a:solidFill>
                  <a:schemeClr val="accent3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Cp</a:t>
            </a:r>
            <a:endParaRPr lang="en-US" b="1" dirty="0">
              <a:solidFill>
                <a:schemeClr val="accent3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95375" y="6269593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K4 Cells</a:t>
            </a:r>
            <a:endParaRPr lang="en-US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14975" y="6257925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C vs </a:t>
            </a:r>
            <a:r>
              <a:rPr lang="en-US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Cm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524375" y="836057"/>
            <a:ext cx="1905000" cy="376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1571471" y="848678"/>
            <a:ext cx="2114704" cy="376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5408608" y="5881211"/>
            <a:ext cx="1905000" cy="376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857173" y="5861208"/>
            <a:ext cx="1905000" cy="376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43000"/>
            <a:ext cx="7772400" cy="777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6444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jacobseb\Documents\path poster 2015\distribution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198"/>
          <a:stretch>
            <a:fillRect/>
          </a:stretch>
        </p:blipFill>
        <p:spPr bwMode="auto">
          <a:xfrm>
            <a:off x="1335088" y="965200"/>
            <a:ext cx="5443537" cy="6254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81263" y="227096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6566280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K:\Ckit RD on bck timecourse blot 5.8.15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5" t="18632" b="67810"/>
          <a:stretch/>
        </p:blipFill>
        <p:spPr bwMode="auto">
          <a:xfrm>
            <a:off x="862149" y="1776549"/>
            <a:ext cx="6699158" cy="524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K:\ERsp1 on bck4 timecourse blot 5.7.15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76" t="26272" b="60421"/>
          <a:stretch/>
        </p:blipFill>
        <p:spPr bwMode="auto">
          <a:xfrm>
            <a:off x="849086" y="2403566"/>
            <a:ext cx="6614931" cy="624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K:\Connexin43 on Bck timecourse blot 4.17.15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530" b="47695"/>
          <a:stretch/>
        </p:blipFill>
        <p:spPr bwMode="auto">
          <a:xfrm>
            <a:off x="880755" y="3161312"/>
            <a:ext cx="6704641" cy="6152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K:\GAPDH on bck timecourse blot 2.20.15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44" t="39994" r="22988" b="42759"/>
          <a:stretch/>
        </p:blipFill>
        <p:spPr bwMode="auto">
          <a:xfrm rot="21321473">
            <a:off x="807050" y="3765680"/>
            <a:ext cx="5246063" cy="1042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1192851" y="3665225"/>
            <a:ext cx="4890051" cy="2870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1160595" y="3612973"/>
            <a:ext cx="5972079" cy="2348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24484" y="1417818"/>
            <a:ext cx="1152239" cy="36403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31870" y="1394988"/>
            <a:ext cx="5443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2                                +                   +                  +                  +</a:t>
            </a:r>
            <a:endParaRPr lang="en-US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1789199" y="1410790"/>
            <a:ext cx="75805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926081" y="1410790"/>
            <a:ext cx="68538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958046" y="1410790"/>
            <a:ext cx="77070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5055326" y="1410790"/>
            <a:ext cx="71586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046103" y="1064622"/>
            <a:ext cx="301686" cy="4062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3116015" y="1064622"/>
            <a:ext cx="301686" cy="4062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208939" y="1064622"/>
            <a:ext cx="301686" cy="4062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238726" y="1119518"/>
            <a:ext cx="418704" cy="98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4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10381" y="1046811"/>
            <a:ext cx="1263487" cy="4062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me (days)</a:t>
            </a:r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6030650" y="1268414"/>
            <a:ext cx="1565267" cy="34734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6806335" y="1861070"/>
            <a:ext cx="603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-Kit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6841601" y="2334431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ER</a:t>
            </a:r>
            <a:r>
              <a:rPr lang="en-US" dirty="0" err="1" smtClean="0">
                <a:latin typeface="Symbol" panose="05050102010706020507" pitchFamily="18" charset="2"/>
              </a:rPr>
              <a:t>a</a:t>
            </a:r>
            <a:endParaRPr lang="en-US" dirty="0">
              <a:latin typeface="Symbol" panose="05050102010706020507" pitchFamily="18" charset="2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767738" y="2931854"/>
            <a:ext cx="641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x43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6540236" y="3946295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543162" y="295733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4</a:t>
            </a:r>
          </a:p>
        </p:txBody>
      </p:sp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3856078"/>
              </p:ext>
            </p:extLst>
          </p:nvPr>
        </p:nvGraphicFramePr>
        <p:xfrm>
          <a:off x="702104" y="4891542"/>
          <a:ext cx="5841630" cy="4472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Prism 7" r:id="rId7" imgW="7540522" imgH="5773990" progId="Prism7.Document">
                  <p:embed/>
                </p:oleObj>
              </mc:Choice>
              <mc:Fallback>
                <p:oleObj name="Prism 7" r:id="rId7" imgW="7540522" imgH="577399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02104" y="4891542"/>
                        <a:ext cx="5841630" cy="4472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Rectangle 27"/>
          <p:cNvSpPr/>
          <p:nvPr/>
        </p:nvSpPr>
        <p:spPr>
          <a:xfrm>
            <a:off x="1138439" y="4363121"/>
            <a:ext cx="5972079" cy="6267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6082902" y="1844625"/>
            <a:ext cx="6078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45 </a:t>
            </a:r>
            <a:r>
              <a:rPr lang="en-US" sz="1000" dirty="0" err="1" smtClean="0"/>
              <a:t>kDa</a:t>
            </a:r>
            <a:endParaRPr lang="en-US" sz="1000" dirty="0" smtClean="0"/>
          </a:p>
          <a:p>
            <a:r>
              <a:rPr lang="en-US" sz="1000" dirty="0" smtClean="0"/>
              <a:t>120 </a:t>
            </a:r>
            <a:r>
              <a:rPr lang="en-US" sz="1000" dirty="0" err="1" smtClean="0"/>
              <a:t>kDa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652806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2789" y="1087333"/>
            <a:ext cx="5829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          </a:t>
            </a:r>
            <a:r>
              <a:rPr lang="en-US" dirty="0" err="1" smtClean="0"/>
              <a:t>MUCp</a:t>
            </a:r>
            <a:r>
              <a:rPr lang="en-US" dirty="0" smtClean="0"/>
              <a:t>                                  </a:t>
            </a:r>
            <a:r>
              <a:rPr lang="en-US" dirty="0" err="1" smtClean="0"/>
              <a:t>MUCm</a:t>
            </a:r>
            <a:r>
              <a:rPr lang="en-US" dirty="0" smtClean="0"/>
              <a:t>                                ILC</a:t>
            </a:r>
            <a:endParaRPr lang="en-US" dirty="0"/>
          </a:p>
        </p:txBody>
      </p:sp>
      <p:pic>
        <p:nvPicPr>
          <p:cNvPr id="5" name="Picture 2" descr="K:\KIT staining BCK tumors\sk17 KIT 40x muc 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79" y="1470575"/>
            <a:ext cx="2216653" cy="16624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K:\KIT staining BCK tumors\sk10 KIT 40x non-muc 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0900" y="1456665"/>
            <a:ext cx="2235199" cy="167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K:\KIT staining BCK tumors\sk10 KIT 40x muc 3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6342" y="1456665"/>
            <a:ext cx="2235200" cy="167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41768" y="2094538"/>
            <a:ext cx="603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-Kit</a:t>
            </a:r>
            <a:endParaRPr lang="en-US" dirty="0"/>
          </a:p>
        </p:txBody>
      </p:sp>
      <p:pic>
        <p:nvPicPr>
          <p:cNvPr id="9" name="Picture 5" descr="K:\cx43 sk10 and sk17 tumors\sk10 40x non-mucinous 1,500ab 2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4642" y="3217561"/>
            <a:ext cx="2209565" cy="1657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6" descr="K:\cx43 sk10 and sk17 tumors\sk10 40x mucinous 1,500ab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8375" y="3209449"/>
            <a:ext cx="2235200" cy="16764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7" descr="K:\cx43 sk10 and sk17 tumors\sk17 40x mucinous 1,500ab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78" y="3217561"/>
            <a:ext cx="2209567" cy="1657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222532" y="3861482"/>
            <a:ext cx="641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x43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578430" y="706333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ellulose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236627" y="668681"/>
            <a:ext cx="413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2</a:t>
            </a:r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3217814" y="999465"/>
            <a:ext cx="45182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056929" y="999465"/>
            <a:ext cx="195025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7" name="Picture 3" descr="K:\er, ck8,18 sk 10-17\40x sk17_3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78" y="4933387"/>
            <a:ext cx="2210372" cy="16577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4" descr="K:\er, ck8,18 sk 10-17\sk11-2 muc_2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6343" y="4934166"/>
            <a:ext cx="2235200" cy="167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5" descr="K:\er, ck8,18 sk 10-17\sk11-2_2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4642" y="4937110"/>
            <a:ext cx="2209565" cy="1657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108719" y="5449200"/>
            <a:ext cx="8691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ER</a:t>
            </a:r>
          </a:p>
          <a:p>
            <a:pPr algn="ctr"/>
            <a:r>
              <a:rPr lang="en-US" dirty="0" smtClean="0">
                <a:solidFill>
                  <a:srgbClr val="FF0066"/>
                </a:solidFill>
              </a:rPr>
              <a:t>CK8/18</a:t>
            </a:r>
            <a:endParaRPr lang="en-US" dirty="0">
              <a:solidFill>
                <a:srgbClr val="FF0066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12663" y="201082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78279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0487969"/>
              </p:ext>
            </p:extLst>
          </p:nvPr>
        </p:nvGraphicFramePr>
        <p:xfrm>
          <a:off x="879475" y="4845191"/>
          <a:ext cx="5830888" cy="510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Prism 7" r:id="rId3" imgW="5648729" imgH="4944555" progId="Prism7.Document">
                  <p:embed/>
                </p:oleObj>
              </mc:Choice>
              <mc:Fallback>
                <p:oleObj name="Prism 7" r:id="rId3" imgW="5648729" imgH="494455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9475" y="4845191"/>
                        <a:ext cx="5830888" cy="5105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53453" y="347412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6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950996" y="905365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hNT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327709" y="905364"/>
            <a:ext cx="103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hKIT340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31627" y="2560667"/>
            <a:ext cx="6367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solidFill>
                  <a:schemeClr val="accent4">
                    <a:lumMod val="50000"/>
                  </a:schemeClr>
                </a:solidFill>
              </a:rPr>
              <a:t>Ki67</a:t>
            </a:r>
            <a:endParaRPr lang="en-US" sz="2000" dirty="0">
              <a:solidFill>
                <a:schemeClr val="accent4">
                  <a:lumMod val="50000"/>
                </a:schemeClr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8274" y="1274696"/>
            <a:ext cx="3616324" cy="310990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643" y="1254656"/>
            <a:ext cx="3626407" cy="311857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349750" y="4156075"/>
            <a:ext cx="748920" cy="635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687387" y="4137023"/>
            <a:ext cx="748920" cy="635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965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48</TotalTime>
  <Words>90</Words>
  <Application>Microsoft Office PowerPoint</Application>
  <PresentationFormat>Custom</PresentationFormat>
  <Paragraphs>42</Paragraphs>
  <Slides>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CU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. Chuck Harrell</dc:creator>
  <cp:lastModifiedBy>Britta</cp:lastModifiedBy>
  <cp:revision>105</cp:revision>
  <cp:lastPrinted>2016-08-04T14:01:10Z</cp:lastPrinted>
  <dcterms:created xsi:type="dcterms:W3CDTF">2016-06-02T14:59:12Z</dcterms:created>
  <dcterms:modified xsi:type="dcterms:W3CDTF">2017-08-09T18:35:37Z</dcterms:modified>
</cp:coreProperties>
</file>